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DF6C29-6BF7-4077-BB9A-2BEAF498D6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10861A9-C419-4844-8B1A-AF699350DB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9DD66C-C967-4685-8B2E-FB51694D9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19672A-8324-46BD-B8C2-0FD257946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300AE6-D579-4EFF-B914-F4AEEC2FB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844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1D94F8-62F4-4433-9F27-72ADCEAA54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EBCB270-D611-477B-8D47-E9116A639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AC02F6-FC99-4933-B6C6-EC05888E6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B5A52D-78DC-4A58-A598-A25C37146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C4ED47-6958-4DD9-A5F9-A5CC48D99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514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E72E5C5-462C-4B8A-92FA-4A52145DB7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8D77A6-53E9-4760-9005-72FB18229A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C90EBA-5976-4267-801C-7C00CF8E4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2C60AD-BABB-4B15-82AB-051E50289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B7BFB6-E72F-47CD-AF59-E0F182640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768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14EFE3-D24A-450C-8049-ADC7C3A2BB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47286E5-8C8E-4EB3-97FA-6419C51CB1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13B48D-A7B9-47FA-9100-813ECB865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7DE84E-1A07-4A62-A9EE-E4A39F941D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ACCE6A-BFA2-4017-B062-28DDD346F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264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F48D23-0A60-4281-B50F-0589BB615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5201E1-C7A1-4818-A4F8-3186CDDBBD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CDAD54-B429-4D8E-87A6-774533C49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00893A-E396-4035-AEBC-67C2FB8D9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08AC8C-AD51-44A5-98FC-448E300FA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8944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CD1B67-7023-4281-A204-7CB53D4AE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72B379-C4DB-4D4D-A793-A004F511EE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1DBA97-CFFB-4EA7-B16D-BFB9EA9F06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4F4E21B-DE30-4CEA-853A-B28E4A5DB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8F701D-6600-4FA9-88EA-31D6F565A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F0B419-0C31-407F-84D4-723177CD7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762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D74218-8EE2-429B-8DF0-49CEAFD68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012250-0DB5-4D5E-ADE8-C54CF6E434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216226-78B7-46A5-B24B-0AAA5B6FB8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EF6C237-7D19-4126-9CA1-10EF3B0998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11BF41B-0A8F-44CD-9CA8-8FB7BFB686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A444A2A-1D83-4728-B1DD-91F0F6E47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1094E5B-EDA5-4E5C-9626-410D95F86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51619B0-7FFC-4838-95D1-50CE1589B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9862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62EF02-76AD-4EB0-AD91-843AD0D384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CBCE0BB-FB5E-484F-8734-2C7668B23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8676325-47E1-44F9-94C2-D14C3A32C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3114F01-8D95-46ED-AE63-4AF4883D2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383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87D75F7-4CBB-4DA7-A9C4-17FCFDDD5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174240B-E24C-4981-81F4-D8FB26EA8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51EE708-4606-4057-846E-976BE28A3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327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1373E9-3B0B-4C6B-82CD-E844D134A8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80CDD6-C9B3-463C-B0AA-91026C52EE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4DDBFA-43FC-404E-93F6-95171A667C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CA5EAE0-75E8-4409-95A7-1D799077B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4AF952-97A6-47BB-BD89-2830C1127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66D916-61B2-4ACB-8845-95D1474A9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3878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288A9D-AFAD-40A2-8891-579670F28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6D491BF-9821-486C-9FA8-8A31BF81F0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E32EFA2-E0B2-40F3-B082-CC7EBB21E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A93CE0-633A-4754-9FF3-39B81E772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CFCBE0-8897-4B35-9F8A-51C667439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D3CDE9-DD4B-4FBD-879F-ED66CF734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935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806BE5E-2FDD-4175-B28F-9C669269F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5EF1AA2-222B-435B-A5DC-10E779738B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4DE095-C94D-477B-9F72-EC2D8664A3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8A6C4-692C-4A1D-8B37-4B7A2BBA883D}" type="datetimeFigureOut">
              <a:rPr lang="zh-CN" altLang="en-US" smtClean="0"/>
              <a:t>2022/9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FF4404-950C-45FC-A6F8-DF351A2881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DA9311-66CC-452B-ACDE-79CE519396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AE115-0471-4F17-8569-F694FA0204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335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0B62A1A-F6A0-4A2F-A4FF-F3672F6A57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4281" y="530486"/>
            <a:ext cx="6010977" cy="24827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49CBC5D-1265-4F63-B6EE-7B7F23D10B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7435" y="3414614"/>
            <a:ext cx="3851910" cy="15672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D890436-13C9-43AD-83E6-83A8F1F32C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3465513"/>
            <a:ext cx="4344482" cy="1426266"/>
          </a:xfrm>
          <a:prstGeom prst="rect">
            <a:avLst/>
          </a:prstGeom>
        </p:spPr>
      </p:pic>
      <p:sp>
        <p:nvSpPr>
          <p:cNvPr id="6" name="梯形 5">
            <a:extLst>
              <a:ext uri="{FF2B5EF4-FFF2-40B4-BE49-F238E27FC236}">
                <a16:creationId xmlns:a16="http://schemas.microsoft.com/office/drawing/2014/main" id="{E1192539-FBC4-453C-BB4D-414E557897C5}"/>
              </a:ext>
            </a:extLst>
          </p:cNvPr>
          <p:cNvSpPr/>
          <p:nvPr/>
        </p:nvSpPr>
        <p:spPr>
          <a:xfrm>
            <a:off x="2082840" y="3013280"/>
            <a:ext cx="3851910" cy="400050"/>
          </a:xfrm>
          <a:prstGeom prst="trapezoid">
            <a:avLst>
              <a:gd name="adj" fmla="val 436630"/>
            </a:avLst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D547FF06-01E3-4061-AE5B-E246B4E43F29}"/>
              </a:ext>
            </a:extLst>
          </p:cNvPr>
          <p:cNvSpPr/>
          <p:nvPr/>
        </p:nvSpPr>
        <p:spPr>
          <a:xfrm>
            <a:off x="3837960" y="530485"/>
            <a:ext cx="370860" cy="24827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3FED296A-C4FF-4DCA-9338-684F764200A0}"/>
              </a:ext>
            </a:extLst>
          </p:cNvPr>
          <p:cNvSpPr/>
          <p:nvPr/>
        </p:nvSpPr>
        <p:spPr>
          <a:xfrm>
            <a:off x="6033907" y="5167062"/>
            <a:ext cx="25266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等线" panose="02010600030101010101" pitchFamily="2" charset="-122"/>
              </a:rPr>
              <a:t>5:140052422-140052422</a:t>
            </a:r>
            <a:r>
              <a:rPr lang="en-US" altLang="zh-CN" sz="1400" dirty="0"/>
              <a:t> </a:t>
            </a:r>
            <a:r>
              <a:rPr lang="en-US" altLang="zh-CN" sz="1400" dirty="0">
                <a:solidFill>
                  <a:srgbClr val="FF0000"/>
                </a:solidFill>
                <a:latin typeface="等线" panose="02010600030101010101" pitchFamily="2" charset="-122"/>
              </a:rPr>
              <a:t>T&gt;G</a:t>
            </a:r>
            <a:r>
              <a:rPr lang="en-US" altLang="zh-CN" sz="1400" dirty="0"/>
              <a:t> </a:t>
            </a:r>
            <a:endParaRPr lang="zh-CN" altLang="en-US" sz="14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BC821EE-B544-4305-9BA1-7927B27C8DF5}"/>
              </a:ext>
            </a:extLst>
          </p:cNvPr>
          <p:cNvSpPr txBox="1"/>
          <p:nvPr/>
        </p:nvSpPr>
        <p:spPr>
          <a:xfrm>
            <a:off x="2621280" y="6057901"/>
            <a:ext cx="61379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[1]	</a:t>
            </a:r>
            <a:r>
              <a:rPr lang="en-US" altLang="zh-CN" sz="1200" dirty="0" err="1"/>
              <a:t>Seelow</a:t>
            </a:r>
            <a:r>
              <a:rPr lang="en-US" altLang="zh-CN" sz="1200" dirty="0"/>
              <a:t>, D., et al., </a:t>
            </a:r>
            <a:r>
              <a:rPr lang="en-US" altLang="zh-CN" sz="1200" i="1" dirty="0" err="1"/>
              <a:t>HomozygosityMapper</a:t>
            </a:r>
            <a:r>
              <a:rPr lang="en-US" altLang="zh-CN" sz="1200" i="1" dirty="0"/>
              <a:t>--an interactive approach to homozygosity mapping.</a:t>
            </a:r>
            <a:r>
              <a:rPr lang="en-US" altLang="zh-CN" sz="1200" dirty="0"/>
              <a:t> Nucleic Acids Res, 2009. </a:t>
            </a:r>
            <a:r>
              <a:rPr lang="en-US" altLang="zh-CN" sz="1200" b="1" dirty="0"/>
              <a:t>37</a:t>
            </a:r>
            <a:r>
              <a:rPr lang="en-US" altLang="zh-CN" sz="1200" dirty="0"/>
              <a:t>(Web Server issue): p. W593-9.</a:t>
            </a:r>
          </a:p>
        </p:txBody>
      </p:sp>
    </p:spTree>
    <p:extLst>
      <p:ext uri="{BB962C8B-B14F-4D97-AF65-F5344CB8AC3E}">
        <p14:creationId xmlns:p14="http://schemas.microsoft.com/office/powerpoint/2010/main" val="1800226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Huan</dc:creator>
  <cp:lastModifiedBy>Sperm X</cp:lastModifiedBy>
  <cp:revision>2</cp:revision>
  <dcterms:created xsi:type="dcterms:W3CDTF">2022-08-29T07:13:57Z</dcterms:created>
  <dcterms:modified xsi:type="dcterms:W3CDTF">2022-09-07T16:29:31Z</dcterms:modified>
</cp:coreProperties>
</file>